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395A20-7A6F-4FD3-8BC6-D5E40C3C0A6B}" v="1" dt="2024-11-14T09:04:17.030"/>
    <p1510:client id="{5361019A-BF92-4CDD-805D-01D6A06CCAF2}" v="37" dt="2024-11-14T09:00:53.2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daf Naqvi" userId="8f91277e-8741-4995-819e-50b4e5326a9f" providerId="ADAL" clId="{5361019A-BF92-4CDD-805D-01D6A06CCAF2}"/>
    <pc:docChg chg="undo custSel addSld delSld modSld">
      <pc:chgData name="Sadaf Naqvi" userId="8f91277e-8741-4995-819e-50b4e5326a9f" providerId="ADAL" clId="{5361019A-BF92-4CDD-805D-01D6A06CCAF2}" dt="2024-11-14T09:00:59.208" v="495" actId="1076"/>
      <pc:docMkLst>
        <pc:docMk/>
      </pc:docMkLst>
      <pc:sldChg chg="modSp del mod">
        <pc:chgData name="Sadaf Naqvi" userId="8f91277e-8741-4995-819e-50b4e5326a9f" providerId="ADAL" clId="{5361019A-BF92-4CDD-805D-01D6A06CCAF2}" dt="2024-11-06T12:49:21.531" v="13" actId="2696"/>
        <pc:sldMkLst>
          <pc:docMk/>
          <pc:sldMk cId="2581505682" sldId="256"/>
        </pc:sldMkLst>
        <pc:spChg chg="mod">
          <ac:chgData name="Sadaf Naqvi" userId="8f91277e-8741-4995-819e-50b4e5326a9f" providerId="ADAL" clId="{5361019A-BF92-4CDD-805D-01D6A06CCAF2}" dt="2024-11-06T09:08:54.118" v="12" actId="20577"/>
          <ac:spMkLst>
            <pc:docMk/>
            <pc:sldMk cId="2581505682" sldId="256"/>
            <ac:spMk id="2" creationId="{5C6BD896-DB52-E558-B85D-BCE7DC1D76BD}"/>
          </ac:spMkLst>
        </pc:spChg>
      </pc:sldChg>
      <pc:sldChg chg="del">
        <pc:chgData name="Sadaf Naqvi" userId="8f91277e-8741-4995-819e-50b4e5326a9f" providerId="ADAL" clId="{5361019A-BF92-4CDD-805D-01D6A06CCAF2}" dt="2024-11-14T08:46:15.288" v="18" actId="2696"/>
        <pc:sldMkLst>
          <pc:docMk/>
          <pc:sldMk cId="2828968604" sldId="257"/>
        </pc:sldMkLst>
      </pc:sldChg>
      <pc:sldChg chg="addSp delSp modSp new del mod">
        <pc:chgData name="Sadaf Naqvi" userId="8f91277e-8741-4995-819e-50b4e5326a9f" providerId="ADAL" clId="{5361019A-BF92-4CDD-805D-01D6A06CCAF2}" dt="2024-11-14T08:46:08.280" v="15" actId="2696"/>
        <pc:sldMkLst>
          <pc:docMk/>
          <pc:sldMk cId="2496051410" sldId="258"/>
        </pc:sldMkLst>
        <pc:spChg chg="mod">
          <ac:chgData name="Sadaf Naqvi" userId="8f91277e-8741-4995-819e-50b4e5326a9f" providerId="ADAL" clId="{5361019A-BF92-4CDD-805D-01D6A06CCAF2}" dt="2024-11-06T09:07:21.113" v="4" actId="20577"/>
          <ac:spMkLst>
            <pc:docMk/>
            <pc:sldMk cId="2496051410" sldId="258"/>
            <ac:spMk id="2" creationId="{40F46B62-FE3B-A1FB-59B0-FAC0EFE5C2C6}"/>
          </ac:spMkLst>
        </pc:spChg>
        <pc:spChg chg="del">
          <ac:chgData name="Sadaf Naqvi" userId="8f91277e-8741-4995-819e-50b4e5326a9f" providerId="ADAL" clId="{5361019A-BF92-4CDD-805D-01D6A06CCAF2}" dt="2024-11-06T09:07:07.734" v="1"/>
          <ac:spMkLst>
            <pc:docMk/>
            <pc:sldMk cId="2496051410" sldId="258"/>
            <ac:spMk id="3" creationId="{49848DC7-A2B3-E841-0C80-81976BD6250A}"/>
          </ac:spMkLst>
        </pc:spChg>
        <pc:picChg chg="add mod">
          <ac:chgData name="Sadaf Naqvi" userId="8f91277e-8741-4995-819e-50b4e5326a9f" providerId="ADAL" clId="{5361019A-BF92-4CDD-805D-01D6A06CCAF2}" dt="2024-11-06T09:07:07.734" v="1"/>
          <ac:picMkLst>
            <pc:docMk/>
            <pc:sldMk cId="2496051410" sldId="258"/>
            <ac:picMk id="4" creationId="{9FF74736-7F07-DD02-ADEF-BE09F886B7D1}"/>
          </ac:picMkLst>
        </pc:picChg>
      </pc:sldChg>
      <pc:sldChg chg="addSp delSp modSp new mod">
        <pc:chgData name="Sadaf Naqvi" userId="8f91277e-8741-4995-819e-50b4e5326a9f" providerId="ADAL" clId="{5361019A-BF92-4CDD-805D-01D6A06CCAF2}" dt="2024-11-14T09:00:59.208" v="495" actId="1076"/>
        <pc:sldMkLst>
          <pc:docMk/>
          <pc:sldMk cId="1453174751" sldId="259"/>
        </pc:sldMkLst>
        <pc:spChg chg="mod">
          <ac:chgData name="Sadaf Naqvi" userId="8f91277e-8741-4995-819e-50b4e5326a9f" providerId="ADAL" clId="{5361019A-BF92-4CDD-805D-01D6A06CCAF2}" dt="2024-11-14T08:48:59.125" v="133" actId="20577"/>
          <ac:spMkLst>
            <pc:docMk/>
            <pc:sldMk cId="1453174751" sldId="259"/>
            <ac:spMk id="2" creationId="{149C5A39-AD4F-1D04-8BB5-29F52A41180F}"/>
          </ac:spMkLst>
        </pc:spChg>
        <pc:spChg chg="del">
          <ac:chgData name="Sadaf Naqvi" userId="8f91277e-8741-4995-819e-50b4e5326a9f" providerId="ADAL" clId="{5361019A-BF92-4CDD-805D-01D6A06CCAF2}" dt="2024-11-14T08:46:45.967" v="19" actId="478"/>
          <ac:spMkLst>
            <pc:docMk/>
            <pc:sldMk cId="1453174751" sldId="259"/>
            <ac:spMk id="3" creationId="{F0B1E7BA-5EAB-053D-0DAE-7D89C012F980}"/>
          </ac:spMkLst>
        </pc:spChg>
        <pc:spChg chg="add mod">
          <ac:chgData name="Sadaf Naqvi" userId="8f91277e-8741-4995-819e-50b4e5326a9f" providerId="ADAL" clId="{5361019A-BF92-4CDD-805D-01D6A06CCAF2}" dt="2024-11-14T08:49:26.975" v="137" actId="207"/>
          <ac:spMkLst>
            <pc:docMk/>
            <pc:sldMk cId="1453174751" sldId="259"/>
            <ac:spMk id="4" creationId="{0AE6096C-A769-2A69-AC59-2F70E39B37BF}"/>
          </ac:spMkLst>
        </pc:spChg>
        <pc:spChg chg="add mod">
          <ac:chgData name="Sadaf Naqvi" userId="8f91277e-8741-4995-819e-50b4e5326a9f" providerId="ADAL" clId="{5361019A-BF92-4CDD-805D-01D6A06CCAF2}" dt="2024-11-14T08:50:02.650" v="145" actId="207"/>
          <ac:spMkLst>
            <pc:docMk/>
            <pc:sldMk cId="1453174751" sldId="259"/>
            <ac:spMk id="5" creationId="{928A6FFF-3A73-A755-ED9A-0EBEDF165257}"/>
          </ac:spMkLst>
        </pc:spChg>
        <pc:spChg chg="add mod">
          <ac:chgData name="Sadaf Naqvi" userId="8f91277e-8741-4995-819e-50b4e5326a9f" providerId="ADAL" clId="{5361019A-BF92-4CDD-805D-01D6A06CCAF2}" dt="2024-11-14T08:50:06.506" v="146" actId="207"/>
          <ac:spMkLst>
            <pc:docMk/>
            <pc:sldMk cId="1453174751" sldId="259"/>
            <ac:spMk id="6" creationId="{F5FCFD82-A3A2-815F-67F9-929404DEF833}"/>
          </ac:spMkLst>
        </pc:spChg>
        <pc:spChg chg="add mod">
          <ac:chgData name="Sadaf Naqvi" userId="8f91277e-8741-4995-819e-50b4e5326a9f" providerId="ADAL" clId="{5361019A-BF92-4CDD-805D-01D6A06CCAF2}" dt="2024-11-14T08:50:11.572" v="147" actId="207"/>
          <ac:spMkLst>
            <pc:docMk/>
            <pc:sldMk cId="1453174751" sldId="259"/>
            <ac:spMk id="7" creationId="{1CF77738-D924-2A8C-8051-EECC1067359B}"/>
          </ac:spMkLst>
        </pc:spChg>
        <pc:spChg chg="add mod">
          <ac:chgData name="Sadaf Naqvi" userId="8f91277e-8741-4995-819e-50b4e5326a9f" providerId="ADAL" clId="{5361019A-BF92-4CDD-805D-01D6A06CCAF2}" dt="2024-11-14T08:50:31.956" v="171" actId="1076"/>
          <ac:spMkLst>
            <pc:docMk/>
            <pc:sldMk cId="1453174751" sldId="259"/>
            <ac:spMk id="8" creationId="{413C2876-5C6F-DF3D-1425-4176C96610EC}"/>
          </ac:spMkLst>
        </pc:spChg>
        <pc:spChg chg="add mod">
          <ac:chgData name="Sadaf Naqvi" userId="8f91277e-8741-4995-819e-50b4e5326a9f" providerId="ADAL" clId="{5361019A-BF92-4CDD-805D-01D6A06CCAF2}" dt="2024-11-14T08:51:08.648" v="199" actId="122"/>
          <ac:spMkLst>
            <pc:docMk/>
            <pc:sldMk cId="1453174751" sldId="259"/>
            <ac:spMk id="9" creationId="{E39C2A00-AFCB-224C-68DF-DE325FC610DA}"/>
          </ac:spMkLst>
        </pc:spChg>
        <pc:spChg chg="add mod">
          <ac:chgData name="Sadaf Naqvi" userId="8f91277e-8741-4995-819e-50b4e5326a9f" providerId="ADAL" clId="{5361019A-BF92-4CDD-805D-01D6A06CCAF2}" dt="2024-11-14T08:51:28.267" v="214" actId="20577"/>
          <ac:spMkLst>
            <pc:docMk/>
            <pc:sldMk cId="1453174751" sldId="259"/>
            <ac:spMk id="10" creationId="{0A321AF4-2542-7608-41ED-CD336D636C29}"/>
          </ac:spMkLst>
        </pc:spChg>
        <pc:spChg chg="add mod">
          <ac:chgData name="Sadaf Naqvi" userId="8f91277e-8741-4995-819e-50b4e5326a9f" providerId="ADAL" clId="{5361019A-BF92-4CDD-805D-01D6A06CCAF2}" dt="2024-11-14T08:51:55.672" v="237" actId="1076"/>
          <ac:spMkLst>
            <pc:docMk/>
            <pc:sldMk cId="1453174751" sldId="259"/>
            <ac:spMk id="11" creationId="{7C41264C-F660-2E93-B27C-5411A1E1BB66}"/>
          </ac:spMkLst>
        </pc:spChg>
        <pc:spChg chg="add mod">
          <ac:chgData name="Sadaf Naqvi" userId="8f91277e-8741-4995-819e-50b4e5326a9f" providerId="ADAL" clId="{5361019A-BF92-4CDD-805D-01D6A06CCAF2}" dt="2024-11-14T08:52:11.809" v="239" actId="1076"/>
          <ac:spMkLst>
            <pc:docMk/>
            <pc:sldMk cId="1453174751" sldId="259"/>
            <ac:spMk id="12" creationId="{14971E17-7F66-C107-2447-7DD0B78C98D5}"/>
          </ac:spMkLst>
        </pc:spChg>
        <pc:spChg chg="add mod">
          <ac:chgData name="Sadaf Naqvi" userId="8f91277e-8741-4995-819e-50b4e5326a9f" providerId="ADAL" clId="{5361019A-BF92-4CDD-805D-01D6A06CCAF2}" dt="2024-11-14T08:52:22.092" v="241" actId="1076"/>
          <ac:spMkLst>
            <pc:docMk/>
            <pc:sldMk cId="1453174751" sldId="259"/>
            <ac:spMk id="13" creationId="{8804DDC9-80DA-0163-C2D7-F668418F5EA2}"/>
          </ac:spMkLst>
        </pc:spChg>
        <pc:spChg chg="add mod">
          <ac:chgData name="Sadaf Naqvi" userId="8f91277e-8741-4995-819e-50b4e5326a9f" providerId="ADAL" clId="{5361019A-BF92-4CDD-805D-01D6A06CCAF2}" dt="2024-11-14T08:52:26.914" v="243" actId="1076"/>
          <ac:spMkLst>
            <pc:docMk/>
            <pc:sldMk cId="1453174751" sldId="259"/>
            <ac:spMk id="14" creationId="{FA2415E5-D269-57E6-B013-7445CBE03921}"/>
          </ac:spMkLst>
        </pc:spChg>
        <pc:spChg chg="add mod">
          <ac:chgData name="Sadaf Naqvi" userId="8f91277e-8741-4995-819e-50b4e5326a9f" providerId="ADAL" clId="{5361019A-BF92-4CDD-805D-01D6A06CCAF2}" dt="2024-11-14T08:52:50.871" v="259" actId="20577"/>
          <ac:spMkLst>
            <pc:docMk/>
            <pc:sldMk cId="1453174751" sldId="259"/>
            <ac:spMk id="15" creationId="{DA9B2BD7-609B-F3C9-093B-704D6B1CB8FD}"/>
          </ac:spMkLst>
        </pc:spChg>
        <pc:spChg chg="add mod">
          <ac:chgData name="Sadaf Naqvi" userId="8f91277e-8741-4995-819e-50b4e5326a9f" providerId="ADAL" clId="{5361019A-BF92-4CDD-805D-01D6A06CCAF2}" dt="2024-11-14T08:53:11.484" v="283" actId="20577"/>
          <ac:spMkLst>
            <pc:docMk/>
            <pc:sldMk cId="1453174751" sldId="259"/>
            <ac:spMk id="16" creationId="{547EEA36-2431-DE89-1E0B-0C37A7D539DC}"/>
          </ac:spMkLst>
        </pc:spChg>
        <pc:spChg chg="add mod">
          <ac:chgData name="Sadaf Naqvi" userId="8f91277e-8741-4995-819e-50b4e5326a9f" providerId="ADAL" clId="{5361019A-BF92-4CDD-805D-01D6A06CCAF2}" dt="2024-11-14T08:53:29.103" v="308" actId="20577"/>
          <ac:spMkLst>
            <pc:docMk/>
            <pc:sldMk cId="1453174751" sldId="259"/>
            <ac:spMk id="17" creationId="{7765BDC7-D00A-F961-C63F-290A371FD987}"/>
          </ac:spMkLst>
        </pc:spChg>
        <pc:spChg chg="add mod">
          <ac:chgData name="Sadaf Naqvi" userId="8f91277e-8741-4995-819e-50b4e5326a9f" providerId="ADAL" clId="{5361019A-BF92-4CDD-805D-01D6A06CCAF2}" dt="2024-11-14T08:53:57.788" v="313" actId="14100"/>
          <ac:spMkLst>
            <pc:docMk/>
            <pc:sldMk cId="1453174751" sldId="259"/>
            <ac:spMk id="18" creationId="{B7DCF0C1-98B1-1162-3FBF-D08E85918193}"/>
          </ac:spMkLst>
        </pc:spChg>
        <pc:spChg chg="add del mod">
          <ac:chgData name="Sadaf Naqvi" userId="8f91277e-8741-4995-819e-50b4e5326a9f" providerId="ADAL" clId="{5361019A-BF92-4CDD-805D-01D6A06CCAF2}" dt="2024-11-14T08:54:04.174" v="314" actId="478"/>
          <ac:spMkLst>
            <pc:docMk/>
            <pc:sldMk cId="1453174751" sldId="259"/>
            <ac:spMk id="19" creationId="{38AC6550-EEBC-620F-0EBF-B70148B5DF22}"/>
          </ac:spMkLst>
        </pc:spChg>
        <pc:spChg chg="add mod">
          <ac:chgData name="Sadaf Naqvi" userId="8f91277e-8741-4995-819e-50b4e5326a9f" providerId="ADAL" clId="{5361019A-BF92-4CDD-805D-01D6A06CCAF2}" dt="2024-11-14T08:54:08.949" v="316" actId="1076"/>
          <ac:spMkLst>
            <pc:docMk/>
            <pc:sldMk cId="1453174751" sldId="259"/>
            <ac:spMk id="20" creationId="{4577D8F2-4CA9-1059-664A-B6FF19D8F9CB}"/>
          </ac:spMkLst>
        </pc:spChg>
        <pc:spChg chg="add mod">
          <ac:chgData name="Sadaf Naqvi" userId="8f91277e-8741-4995-819e-50b4e5326a9f" providerId="ADAL" clId="{5361019A-BF92-4CDD-805D-01D6A06CCAF2}" dt="2024-11-14T08:55:54.534" v="374" actId="1076"/>
          <ac:spMkLst>
            <pc:docMk/>
            <pc:sldMk cId="1453174751" sldId="259"/>
            <ac:spMk id="21" creationId="{8D23DFC5-0BB7-3073-B835-3F4250B23C30}"/>
          </ac:spMkLst>
        </pc:spChg>
        <pc:spChg chg="add mod">
          <ac:chgData name="Sadaf Naqvi" userId="8f91277e-8741-4995-819e-50b4e5326a9f" providerId="ADAL" clId="{5361019A-BF92-4CDD-805D-01D6A06CCAF2}" dt="2024-11-14T08:55:59.569" v="375" actId="255"/>
          <ac:spMkLst>
            <pc:docMk/>
            <pc:sldMk cId="1453174751" sldId="259"/>
            <ac:spMk id="22" creationId="{F808A97A-F9F9-4F6B-5B32-FC49CDE9BC5D}"/>
          </ac:spMkLst>
        </pc:spChg>
        <pc:spChg chg="add mod">
          <ac:chgData name="Sadaf Naqvi" userId="8f91277e-8741-4995-819e-50b4e5326a9f" providerId="ADAL" clId="{5361019A-BF92-4CDD-805D-01D6A06CCAF2}" dt="2024-11-14T08:55:06.891" v="364"/>
          <ac:spMkLst>
            <pc:docMk/>
            <pc:sldMk cId="1453174751" sldId="259"/>
            <ac:spMk id="23" creationId="{20C2BC78-438B-AE91-3AA6-7118497FF964}"/>
          </ac:spMkLst>
        </pc:spChg>
        <pc:spChg chg="add mod">
          <ac:chgData name="Sadaf Naqvi" userId="8f91277e-8741-4995-819e-50b4e5326a9f" providerId="ADAL" clId="{5361019A-BF92-4CDD-805D-01D6A06CCAF2}" dt="2024-11-14T08:55:22.796" v="366" actId="1076"/>
          <ac:spMkLst>
            <pc:docMk/>
            <pc:sldMk cId="1453174751" sldId="259"/>
            <ac:spMk id="24" creationId="{58201475-2CCB-E270-2012-5767053FBC64}"/>
          </ac:spMkLst>
        </pc:spChg>
        <pc:spChg chg="add mod">
          <ac:chgData name="Sadaf Naqvi" userId="8f91277e-8741-4995-819e-50b4e5326a9f" providerId="ADAL" clId="{5361019A-BF92-4CDD-805D-01D6A06CCAF2}" dt="2024-11-14T08:55:31.156" v="368" actId="1076"/>
          <ac:spMkLst>
            <pc:docMk/>
            <pc:sldMk cId="1453174751" sldId="259"/>
            <ac:spMk id="25" creationId="{E47D2E80-C1E8-5220-F6EF-EEC960C1A26D}"/>
          </ac:spMkLst>
        </pc:spChg>
        <pc:spChg chg="add mod">
          <ac:chgData name="Sadaf Naqvi" userId="8f91277e-8741-4995-819e-50b4e5326a9f" providerId="ADAL" clId="{5361019A-BF92-4CDD-805D-01D6A06CCAF2}" dt="2024-11-14T08:55:39.792" v="370" actId="1076"/>
          <ac:spMkLst>
            <pc:docMk/>
            <pc:sldMk cId="1453174751" sldId="259"/>
            <ac:spMk id="26" creationId="{02C7F486-4B4A-F9B2-C8DC-85BB85F52FDA}"/>
          </ac:spMkLst>
        </pc:spChg>
        <pc:spChg chg="add mod">
          <ac:chgData name="Sadaf Naqvi" userId="8f91277e-8741-4995-819e-50b4e5326a9f" providerId="ADAL" clId="{5361019A-BF92-4CDD-805D-01D6A06CCAF2}" dt="2024-11-14T08:55:44.757" v="372" actId="1076"/>
          <ac:spMkLst>
            <pc:docMk/>
            <pc:sldMk cId="1453174751" sldId="259"/>
            <ac:spMk id="27" creationId="{F6113A5D-09F0-729A-5A32-50B5A5960CD4}"/>
          </ac:spMkLst>
        </pc:spChg>
        <pc:spChg chg="add mod">
          <ac:chgData name="Sadaf Naqvi" userId="8f91277e-8741-4995-819e-50b4e5326a9f" providerId="ADAL" clId="{5361019A-BF92-4CDD-805D-01D6A06CCAF2}" dt="2024-11-14T08:56:11.362" v="387" actId="5793"/>
          <ac:spMkLst>
            <pc:docMk/>
            <pc:sldMk cId="1453174751" sldId="259"/>
            <ac:spMk id="28" creationId="{B09CF38A-B20E-08DD-994E-663895BBFA5B}"/>
          </ac:spMkLst>
        </pc:spChg>
        <pc:spChg chg="add mod">
          <ac:chgData name="Sadaf Naqvi" userId="8f91277e-8741-4995-819e-50b4e5326a9f" providerId="ADAL" clId="{5361019A-BF92-4CDD-805D-01D6A06CCAF2}" dt="2024-11-14T08:56:23.376" v="391" actId="20577"/>
          <ac:spMkLst>
            <pc:docMk/>
            <pc:sldMk cId="1453174751" sldId="259"/>
            <ac:spMk id="29" creationId="{C3F84770-5E16-713C-F991-CC78574FAAD8}"/>
          </ac:spMkLst>
        </pc:spChg>
        <pc:spChg chg="add mod">
          <ac:chgData name="Sadaf Naqvi" userId="8f91277e-8741-4995-819e-50b4e5326a9f" providerId="ADAL" clId="{5361019A-BF92-4CDD-805D-01D6A06CCAF2}" dt="2024-11-14T08:56:54.009" v="422" actId="1076"/>
          <ac:spMkLst>
            <pc:docMk/>
            <pc:sldMk cId="1453174751" sldId="259"/>
            <ac:spMk id="30" creationId="{49F35A1E-8B00-B17C-EE90-BF5C55781338}"/>
          </ac:spMkLst>
        </pc:spChg>
        <pc:spChg chg="add mod">
          <ac:chgData name="Sadaf Naqvi" userId="8f91277e-8741-4995-819e-50b4e5326a9f" providerId="ADAL" clId="{5361019A-BF92-4CDD-805D-01D6A06CCAF2}" dt="2024-11-14T08:57:16.871" v="455" actId="20577"/>
          <ac:spMkLst>
            <pc:docMk/>
            <pc:sldMk cId="1453174751" sldId="259"/>
            <ac:spMk id="31" creationId="{55C1436E-C490-EC1C-B748-D63C583D63A0}"/>
          </ac:spMkLst>
        </pc:spChg>
        <pc:grpChg chg="add mod">
          <ac:chgData name="Sadaf Naqvi" userId="8f91277e-8741-4995-819e-50b4e5326a9f" providerId="ADAL" clId="{5361019A-BF92-4CDD-805D-01D6A06CCAF2}" dt="2024-11-14T09:00:43.835" v="491" actId="164"/>
          <ac:grpSpMkLst>
            <pc:docMk/>
            <pc:sldMk cId="1453174751" sldId="259"/>
            <ac:grpSpMk id="56" creationId="{639A02B2-53F8-5DDE-7338-2B2986772C0F}"/>
          </ac:grpSpMkLst>
        </pc:grpChg>
        <pc:grpChg chg="add mod">
          <ac:chgData name="Sadaf Naqvi" userId="8f91277e-8741-4995-819e-50b4e5326a9f" providerId="ADAL" clId="{5361019A-BF92-4CDD-805D-01D6A06CCAF2}" dt="2024-11-14T09:00:51.767" v="493" actId="1076"/>
          <ac:grpSpMkLst>
            <pc:docMk/>
            <pc:sldMk cId="1453174751" sldId="259"/>
            <ac:grpSpMk id="57" creationId="{F11DF799-9CF3-A234-66D0-2BF30A1FE3AB}"/>
          </ac:grpSpMkLst>
        </pc:grpChg>
        <pc:grpChg chg="add mod">
          <ac:chgData name="Sadaf Naqvi" userId="8f91277e-8741-4995-819e-50b4e5326a9f" providerId="ADAL" clId="{5361019A-BF92-4CDD-805D-01D6A06CCAF2}" dt="2024-11-14T09:00:59.208" v="495" actId="1076"/>
          <ac:grpSpMkLst>
            <pc:docMk/>
            <pc:sldMk cId="1453174751" sldId="259"/>
            <ac:grpSpMk id="62" creationId="{7B3E6414-E5BF-647A-4892-14AD134CA126}"/>
          </ac:grpSpMkLst>
        </pc:grpChg>
        <pc:cxnChg chg="add">
          <ac:chgData name="Sadaf Naqvi" userId="8f91277e-8741-4995-819e-50b4e5326a9f" providerId="ADAL" clId="{5361019A-BF92-4CDD-805D-01D6A06CCAF2}" dt="2024-11-14T08:57:36.752" v="456" actId="11529"/>
          <ac:cxnSpMkLst>
            <pc:docMk/>
            <pc:sldMk cId="1453174751" sldId="259"/>
            <ac:cxnSpMk id="33" creationId="{61D863BC-EDB5-3BA6-6099-4C3B188E6BEE}"/>
          </ac:cxnSpMkLst>
        </pc:cxnChg>
        <pc:cxnChg chg="add mod">
          <ac:chgData name="Sadaf Naqvi" userId="8f91277e-8741-4995-819e-50b4e5326a9f" providerId="ADAL" clId="{5361019A-BF92-4CDD-805D-01D6A06CCAF2}" dt="2024-11-14T08:57:55.766" v="458" actId="1076"/>
          <ac:cxnSpMkLst>
            <pc:docMk/>
            <pc:sldMk cId="1453174751" sldId="259"/>
            <ac:cxnSpMk id="35" creationId="{1F1AF263-0350-BA87-ACDA-B239F5D1604F}"/>
          </ac:cxnSpMkLst>
        </pc:cxnChg>
        <pc:cxnChg chg="add">
          <ac:chgData name="Sadaf Naqvi" userId="8f91277e-8741-4995-819e-50b4e5326a9f" providerId="ADAL" clId="{5361019A-BF92-4CDD-805D-01D6A06CCAF2}" dt="2024-11-14T08:58:02.318" v="459" actId="11529"/>
          <ac:cxnSpMkLst>
            <pc:docMk/>
            <pc:sldMk cId="1453174751" sldId="259"/>
            <ac:cxnSpMk id="37" creationId="{6D907DD3-61A1-C552-3E53-F7F67CEE2E83}"/>
          </ac:cxnSpMkLst>
        </pc:cxnChg>
        <pc:cxnChg chg="add mod">
          <ac:chgData name="Sadaf Naqvi" userId="8f91277e-8741-4995-819e-50b4e5326a9f" providerId="ADAL" clId="{5361019A-BF92-4CDD-805D-01D6A06CCAF2}" dt="2024-11-14T08:58:10.627" v="461" actId="1076"/>
          <ac:cxnSpMkLst>
            <pc:docMk/>
            <pc:sldMk cId="1453174751" sldId="259"/>
            <ac:cxnSpMk id="38" creationId="{C9A459DE-E50E-96F6-4B30-02E4C09B1FA2}"/>
          </ac:cxnSpMkLst>
        </pc:cxnChg>
        <pc:cxnChg chg="add mod">
          <ac:chgData name="Sadaf Naqvi" userId="8f91277e-8741-4995-819e-50b4e5326a9f" providerId="ADAL" clId="{5361019A-BF92-4CDD-805D-01D6A06CCAF2}" dt="2024-11-14T08:58:19.309" v="463" actId="1076"/>
          <ac:cxnSpMkLst>
            <pc:docMk/>
            <pc:sldMk cId="1453174751" sldId="259"/>
            <ac:cxnSpMk id="39" creationId="{165AC379-1BBB-A7AC-7F12-299052C93F1C}"/>
          </ac:cxnSpMkLst>
        </pc:cxnChg>
        <pc:cxnChg chg="add mod">
          <ac:chgData name="Sadaf Naqvi" userId="8f91277e-8741-4995-819e-50b4e5326a9f" providerId="ADAL" clId="{5361019A-BF92-4CDD-805D-01D6A06CCAF2}" dt="2024-11-14T08:58:29.349" v="466" actId="14100"/>
          <ac:cxnSpMkLst>
            <pc:docMk/>
            <pc:sldMk cId="1453174751" sldId="259"/>
            <ac:cxnSpMk id="40" creationId="{894E7169-44C2-8785-91B0-632F5CE482DC}"/>
          </ac:cxnSpMkLst>
        </pc:cxnChg>
        <pc:cxnChg chg="add mod">
          <ac:chgData name="Sadaf Naqvi" userId="8f91277e-8741-4995-819e-50b4e5326a9f" providerId="ADAL" clId="{5361019A-BF92-4CDD-805D-01D6A06CCAF2}" dt="2024-11-14T08:58:38.966" v="468" actId="1076"/>
          <ac:cxnSpMkLst>
            <pc:docMk/>
            <pc:sldMk cId="1453174751" sldId="259"/>
            <ac:cxnSpMk id="42" creationId="{DC592D87-DEF6-952B-5D8A-5CB41BD7CE70}"/>
          </ac:cxnSpMkLst>
        </pc:cxnChg>
        <pc:cxnChg chg="add mod">
          <ac:chgData name="Sadaf Naqvi" userId="8f91277e-8741-4995-819e-50b4e5326a9f" providerId="ADAL" clId="{5361019A-BF92-4CDD-805D-01D6A06CCAF2}" dt="2024-11-14T08:58:43.892" v="470" actId="1076"/>
          <ac:cxnSpMkLst>
            <pc:docMk/>
            <pc:sldMk cId="1453174751" sldId="259"/>
            <ac:cxnSpMk id="43" creationId="{7CBA9AA6-B2F7-30E8-5357-86C37DA86C8F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45" creationId="{57299F36-D8FA-452C-E20D-28D97B034C7D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47" creationId="{2D699CA4-875F-92E7-AD7F-6119D3F53174}"/>
          </ac:cxnSpMkLst>
        </pc:cxnChg>
        <pc:cxnChg chg="add del mod">
          <ac:chgData name="Sadaf Naqvi" userId="8f91277e-8741-4995-819e-50b4e5326a9f" providerId="ADAL" clId="{5361019A-BF92-4CDD-805D-01D6A06CCAF2}" dt="2024-11-14T08:59:48.468" v="484" actId="478"/>
          <ac:cxnSpMkLst>
            <pc:docMk/>
            <pc:sldMk cId="1453174751" sldId="259"/>
            <ac:cxnSpMk id="48" creationId="{24C380FD-0569-1F7F-A704-26D3E7EBE095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53" creationId="{4BA228DD-BC8B-3C9A-9D89-0CA9081FCC49}"/>
          </ac:cxnSpMkLst>
        </pc:cxnChg>
        <pc:cxnChg chg="add mod">
          <ac:chgData name="Sadaf Naqvi" userId="8f91277e-8741-4995-819e-50b4e5326a9f" providerId="ADAL" clId="{5361019A-BF92-4CDD-805D-01D6A06CCAF2}" dt="2024-11-14T09:00:43.835" v="491" actId="164"/>
          <ac:cxnSpMkLst>
            <pc:docMk/>
            <pc:sldMk cId="1453174751" sldId="259"/>
            <ac:cxnSpMk id="54" creationId="{D88162E4-76CD-3B5A-ACA8-D03988EEB0D9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58" creationId="{7E115793-EABA-1DD4-563A-4BB5C96F15CA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59" creationId="{810D9E2F-D0A8-3D90-F1E1-040C60C41597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60" creationId="{FAF95213-8671-E601-A135-6D34C70DB9E7}"/>
          </ac:cxnSpMkLst>
        </pc:cxnChg>
        <pc:cxnChg chg="mod">
          <ac:chgData name="Sadaf Naqvi" userId="8f91277e-8741-4995-819e-50b4e5326a9f" providerId="ADAL" clId="{5361019A-BF92-4CDD-805D-01D6A06CCAF2}" dt="2024-11-14T09:00:47.654" v="492"/>
          <ac:cxnSpMkLst>
            <pc:docMk/>
            <pc:sldMk cId="1453174751" sldId="259"/>
            <ac:cxnSpMk id="61" creationId="{A8C81FFF-4367-885F-EFD0-2647939D92A8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3" creationId="{F5EE7167-66B2-5228-436A-14E8EDCC12AC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4" creationId="{435E0073-BED9-CA32-A292-8AB07A215248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5" creationId="{AB18AC90-0418-98AB-7B3C-28D0B78BCCB2}"/>
          </ac:cxnSpMkLst>
        </pc:cxnChg>
        <pc:cxnChg chg="mod">
          <ac:chgData name="Sadaf Naqvi" userId="8f91277e-8741-4995-819e-50b4e5326a9f" providerId="ADAL" clId="{5361019A-BF92-4CDD-805D-01D6A06CCAF2}" dt="2024-11-14T09:00:53.233" v="494"/>
          <ac:cxnSpMkLst>
            <pc:docMk/>
            <pc:sldMk cId="1453174751" sldId="259"/>
            <ac:cxnSpMk id="66" creationId="{DE7C9D04-9C83-30A5-A64F-1FDB34E0CB07}"/>
          </ac:cxnSpMkLst>
        </pc:cxnChg>
      </pc:sldChg>
      <pc:sldChg chg="add del">
        <pc:chgData name="Sadaf Naqvi" userId="8f91277e-8741-4995-819e-50b4e5326a9f" providerId="ADAL" clId="{5361019A-BF92-4CDD-805D-01D6A06CCAF2}" dt="2024-11-14T08:46:13.072" v="17" actId="2696"/>
        <pc:sldMkLst>
          <pc:docMk/>
          <pc:sldMk cId="2459421142" sldId="260"/>
        </pc:sldMkLst>
      </pc:sldChg>
    </pc:docChg>
  </pc:docChgLst>
  <pc:docChgLst>
    <pc:chgData name="Sadaf Naqvi" userId="8f91277e-8741-4995-819e-50b4e5326a9f" providerId="ADAL" clId="{32395A20-7A6F-4FD3-8BC6-D5E40C3C0A6B}"/>
    <pc:docChg chg="custSel addSld delSld modSld">
      <pc:chgData name="Sadaf Naqvi" userId="8f91277e-8741-4995-819e-50b4e5326a9f" providerId="ADAL" clId="{32395A20-7A6F-4FD3-8BC6-D5E40C3C0A6B}" dt="2024-11-14T09:05:23.588" v="136" actId="20577"/>
      <pc:docMkLst>
        <pc:docMk/>
      </pc:docMkLst>
      <pc:sldChg chg="del">
        <pc:chgData name="Sadaf Naqvi" userId="8f91277e-8741-4995-819e-50b4e5326a9f" providerId="ADAL" clId="{32395A20-7A6F-4FD3-8BC6-D5E40C3C0A6B}" dt="2024-11-14T09:04:02.954" v="1" actId="2696"/>
        <pc:sldMkLst>
          <pc:docMk/>
          <pc:sldMk cId="1453174751" sldId="259"/>
        </pc:sldMkLst>
      </pc:sldChg>
      <pc:sldChg chg="addSp delSp modSp new mod">
        <pc:chgData name="Sadaf Naqvi" userId="8f91277e-8741-4995-819e-50b4e5326a9f" providerId="ADAL" clId="{32395A20-7A6F-4FD3-8BC6-D5E40C3C0A6B}" dt="2024-11-14T09:05:23.588" v="136" actId="20577"/>
        <pc:sldMkLst>
          <pc:docMk/>
          <pc:sldMk cId="1468733605" sldId="260"/>
        </pc:sldMkLst>
        <pc:spChg chg="mod">
          <ac:chgData name="Sadaf Naqvi" userId="8f91277e-8741-4995-819e-50b4e5326a9f" providerId="ADAL" clId="{32395A20-7A6F-4FD3-8BC6-D5E40C3C0A6B}" dt="2024-11-14T09:05:23.588" v="136" actId="20577"/>
          <ac:spMkLst>
            <pc:docMk/>
            <pc:sldMk cId="1468733605" sldId="260"/>
            <ac:spMk id="2" creationId="{7A0440A5-603F-9324-4E37-B965621D0C80}"/>
          </ac:spMkLst>
        </pc:spChg>
        <pc:spChg chg="del">
          <ac:chgData name="Sadaf Naqvi" userId="8f91277e-8741-4995-819e-50b4e5326a9f" providerId="ADAL" clId="{32395A20-7A6F-4FD3-8BC6-D5E40C3C0A6B}" dt="2024-11-14T09:04:15.469" v="2" actId="478"/>
          <ac:spMkLst>
            <pc:docMk/>
            <pc:sldMk cId="1468733605" sldId="260"/>
            <ac:spMk id="3" creationId="{F4BA680F-60AB-29D2-AE7C-CAD3C529CB9B}"/>
          </ac:spMkLst>
        </pc:spChg>
        <pc:picChg chg="add mod">
          <ac:chgData name="Sadaf Naqvi" userId="8f91277e-8741-4995-819e-50b4e5326a9f" providerId="ADAL" clId="{32395A20-7A6F-4FD3-8BC6-D5E40C3C0A6B}" dt="2024-11-14T09:04:17.030" v="3"/>
          <ac:picMkLst>
            <pc:docMk/>
            <pc:sldMk cId="1468733605" sldId="260"/>
            <ac:picMk id="4" creationId="{599ECC1B-7FFB-4384-1F92-3CA49072D3E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8C48D-A486-6E89-6C7A-DC833FB704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09A8B7-7800-1F97-2344-E131617DFD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366FD-B4DB-7EB3-69FA-70BDCA504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4FAAD-A448-519A-AC74-50CBFBD97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D17C6-AFC6-52D8-5D09-37C200C8C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423005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0367E-44C3-D1F7-62F1-54693037B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A70232-D37C-8C45-3A9C-D7D5350FC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FFC4D-41FB-8A01-C48C-9E7AB1434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29CD3-BA08-0FC5-BB65-2EF7CAEF8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00B12C-0D6F-5AC1-F8ED-37D2569C3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30704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D219A9-A91D-C7A5-6CBD-D0B41679C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E5AA97-77DB-C15D-C0D5-957D75A955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BCB0CF-3EDD-7C6D-DEB6-7549EFB1D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D1FB4-5087-A930-5B78-8BF082608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24C854-BD81-F980-759A-021C54D2D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41724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C1290-586E-2DDF-F1DA-C4EA47D6C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49588F-3FF8-65AA-A891-CCD573DF01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FCD04-BFDA-C0C3-43C4-94C469968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1D8EFA-A88B-96B4-FF06-8B64917C1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DC422-253A-BB67-0AF2-1E99BEA21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92441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28A11-838D-D2DD-55B4-6C63FA743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D0C543-2535-07EB-B2F0-3312E7BF0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2F60-B38A-792B-5C0F-5D7DDFC8F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901F2-3097-0969-8A91-238962959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00D6CD-716B-DDAE-9196-7A976DC3A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200760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ACE48-9899-EED3-1FC4-4840D8326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3CD23E-A8B0-A862-1CD6-9F19A2B64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A0B39-F16D-D778-642D-3F7907FC26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0BB97-F3DD-F112-1284-8E370C5F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E3B947-9CFA-9355-9938-83716C32E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094360-C2EE-15FC-9D07-C95C64E55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178834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09226A-3E98-6E2C-6076-76A840B38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3905A3-2FD2-E093-6C79-E6082BC952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AD6E32-8D3C-04CF-B236-F1EB000A8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6B2E07-3657-7CE3-071E-AE71849719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B4621F-129A-4765-2034-2AC1BC7AF7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77AA78-6B7C-05E0-DBD1-54C009C86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D5CBAC-CF07-E87F-EA51-5447FD63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04EC99-3FC4-2CCC-AB2C-480CF7ACC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73847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9A408-574A-C2D3-DBE3-4FBB9E05F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93148F-C0CD-D23A-2717-216D09552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D63BCC-DBA8-D378-4D42-0F379F7D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E92133-D309-DEED-0999-67A24FC01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942059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E16AF3-921C-DF98-4624-AC09DE867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197E7C-B0F6-F9A3-8683-4A9337C1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450C66-C365-F829-171C-02C62AA3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981753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DF864-A919-6F29-1BD7-5CFEB91D1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10DAE7-6B29-965F-37F8-149486260B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EABF2F-38E4-0EE4-9996-53BFE050E6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9D6B5-9D01-F30D-4159-55F9DBD59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DFDA9-F64B-1FFD-789B-2C0A84362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AE6F0-13C2-3050-C08A-0E61BCD8A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5346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F4C22-D012-ADED-149E-2EECDBE47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A5229D-5729-4C84-A459-AC2F81ADA9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B3EC1-9AC3-71DC-3152-2C31E60DDF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37BE77-09DB-BE68-F16D-51E0EF033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159977-7F6B-276B-0522-F5E17DEF0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7D6283-0C91-BE41-CDC0-5822DEB60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182148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3B1B0-CD18-7AA8-63A5-F312D126B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9DD10-F90E-FC0F-E0DE-6A4CB3E62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EA191F-B78C-5713-36C0-FC9FA45A58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6BCEB6-4DF0-424E-8860-7C3EE7D77D90}" type="datetimeFigureOut">
              <a:rPr lang="en-AE" smtClean="0"/>
              <a:t>14/11/2024</a:t>
            </a:fld>
            <a:endParaRPr lang="en-A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8C02B-9201-A477-6705-D22C8BD4B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21A6F-A45E-93A5-4616-55CCBD971C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AE1629-D5CD-4A53-BBA5-5B2B03DDD6E7}" type="slidenum">
              <a:rPr lang="en-AE" smtClean="0"/>
              <a:t>‹#›</a:t>
            </a:fld>
            <a:endParaRPr lang="en-AE"/>
          </a:p>
        </p:txBody>
      </p:sp>
    </p:spTree>
    <p:extLst>
      <p:ext uri="{BB962C8B-B14F-4D97-AF65-F5344CB8AC3E}">
        <p14:creationId xmlns:p14="http://schemas.microsoft.com/office/powerpoint/2010/main" val="3576806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440A5-603F-9324-4E37-B965621D0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/>
              <a:t>Figure 3: A screenshot of the Data Dashboard showing real time analytics for PHC visits in a day</a:t>
            </a:r>
            <a:endParaRPr lang="en-AE" sz="2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99ECC1B-7FFB-4384-1F92-3CA49072D3E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0245" y="1951037"/>
            <a:ext cx="5731510" cy="295592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68733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Figure 3: A screenshot of the Data Dashboard showing real time analytics for PHC visits in a da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daf Naqvi</dc:creator>
  <cp:lastModifiedBy>Sadaf Naqvi</cp:lastModifiedBy>
  <cp:revision>1</cp:revision>
  <dcterms:created xsi:type="dcterms:W3CDTF">2024-11-06T09:04:20Z</dcterms:created>
  <dcterms:modified xsi:type="dcterms:W3CDTF">2024-11-14T09:05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76ce46-357f-46de-88d6-77b9bbb83c46_Enabled">
    <vt:lpwstr>true</vt:lpwstr>
  </property>
  <property fmtid="{D5CDD505-2E9C-101B-9397-08002B2CF9AE}" pid="3" name="MSIP_Label_3c76ce46-357f-46de-88d6-77b9bbb83c46_SetDate">
    <vt:lpwstr>2024-11-06T09:05:46Z</vt:lpwstr>
  </property>
  <property fmtid="{D5CDD505-2E9C-101B-9397-08002B2CF9AE}" pid="4" name="MSIP_Label_3c76ce46-357f-46de-88d6-77b9bbb83c46_Method">
    <vt:lpwstr>Privileged</vt:lpwstr>
  </property>
  <property fmtid="{D5CDD505-2E9C-101B-9397-08002B2CF9AE}" pid="5" name="MSIP_Label_3c76ce46-357f-46de-88d6-77b9bbb83c46_Name">
    <vt:lpwstr>Public</vt:lpwstr>
  </property>
  <property fmtid="{D5CDD505-2E9C-101B-9397-08002B2CF9AE}" pid="6" name="MSIP_Label_3c76ce46-357f-46de-88d6-77b9bbb83c46_SiteId">
    <vt:lpwstr>4e2c6054-71cb-48f1-bd6c-3a9705aca71b</vt:lpwstr>
  </property>
  <property fmtid="{D5CDD505-2E9C-101B-9397-08002B2CF9AE}" pid="7" name="MSIP_Label_3c76ce46-357f-46de-88d6-77b9bbb83c46_ActionId">
    <vt:lpwstr>6109e0eb-3837-46db-a36e-5089aca50507</vt:lpwstr>
  </property>
  <property fmtid="{D5CDD505-2E9C-101B-9397-08002B2CF9AE}" pid="8" name="MSIP_Label_3c76ce46-357f-46de-88d6-77b9bbb83c46_ContentBits">
    <vt:lpwstr>0</vt:lpwstr>
  </property>
</Properties>
</file>